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14672D-65C8-4483-A074-450A9EC4A77E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E3895D6-5CC0-4C15-BE5C-676186B72938}" type="slidenum">
              <a:rPr b="0" lang="ja-JP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2"/>
          <p:cNvSpPr/>
          <p:nvPr/>
        </p:nvSpPr>
        <p:spPr>
          <a:xfrm>
            <a:off x="3882960" y="8685360"/>
            <a:ext cx="2962440" cy="44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B294A7C9-7BCA-4AAD-9D75-5A490F911B40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1"/>
          <p:cNvSpPr/>
          <p:nvPr/>
        </p:nvSpPr>
        <p:spPr>
          <a:xfrm>
            <a:off x="1143000" y="685800"/>
            <a:ext cx="457056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1"/>
          <p:cNvSpPr>
            <a:spLocks noGrp="1"/>
          </p:cNvSpPr>
          <p:nvPr>
            <p:ph type="body"/>
          </p:nvPr>
        </p:nvSpPr>
        <p:spPr>
          <a:xfrm>
            <a:off x="539280" y="4432320"/>
            <a:ext cx="5483160" cy="4208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プロモーターが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の発言に最も重要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ATEX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の結果と矛盾しない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3491C-C125-4231-B778-84D804C540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F165F8-39EA-4482-A19B-33F9688A35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E1CBF4-7086-4755-8B40-31582CAC545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F0DFCD-9050-4D73-A4ED-2772410AAA9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E8E71-C399-4AB1-A00B-6F30F25281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ACE00-6BA5-44F9-9E5C-6AB044806A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A283E-E42C-4996-8288-A542530697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5E8BC-E113-4A23-A015-9C0FF1EC4C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022020-06BE-49AC-B96E-93A8C282D1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83B9A9-1FD3-4FBC-A4BF-1CBEA05BDA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06C76-0AB4-4AEC-B46E-6271567BF8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A6B936-27F8-4DCD-A685-CF50A838C7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5367BB-CE8D-47EA-A92D-148C711EA29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1"/>
          <p:cNvGrpSpPr/>
          <p:nvPr/>
        </p:nvGrpSpPr>
        <p:grpSpPr>
          <a:xfrm>
            <a:off x="1236960" y="1341360"/>
            <a:ext cx="6430680" cy="2954160"/>
            <a:chOff x="1236960" y="1341360"/>
            <a:chExt cx="6430680" cy="2954160"/>
          </a:xfrm>
        </p:grpSpPr>
        <p:sp>
          <p:nvSpPr>
            <p:cNvPr id="49" name="Line 1"/>
            <p:cNvSpPr/>
            <p:nvPr/>
          </p:nvSpPr>
          <p:spPr>
            <a:xfrm>
              <a:off x="2340000" y="2230560"/>
              <a:ext cx="53276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0" name="Group 2"/>
            <p:cNvGrpSpPr/>
            <p:nvPr/>
          </p:nvGrpSpPr>
          <p:grpSpPr>
            <a:xfrm>
              <a:off x="3995640" y="2014560"/>
              <a:ext cx="285840" cy="212760"/>
              <a:chOff x="3995640" y="2014560"/>
              <a:chExt cx="285840" cy="212760"/>
            </a:xfrm>
          </p:grpSpPr>
          <p:sp>
            <p:nvSpPr>
              <p:cNvPr id="51" name="Line 3"/>
              <p:cNvSpPr/>
              <p:nvPr/>
            </p:nvSpPr>
            <p:spPr>
              <a:xfrm>
                <a:off x="3995640" y="2014560"/>
                <a:ext cx="2858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Line 4"/>
              <p:cNvSpPr/>
              <p:nvPr/>
            </p:nvSpPr>
            <p:spPr>
              <a:xfrm>
                <a:off x="3995640" y="2014560"/>
                <a:ext cx="1440" cy="21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" name="Group 5"/>
            <p:cNvGrpSpPr/>
            <p:nvPr/>
          </p:nvGrpSpPr>
          <p:grpSpPr>
            <a:xfrm>
              <a:off x="5291280" y="2014560"/>
              <a:ext cx="285480" cy="212760"/>
              <a:chOff x="5291280" y="2014560"/>
              <a:chExt cx="285480" cy="212760"/>
            </a:xfrm>
          </p:grpSpPr>
          <p:sp>
            <p:nvSpPr>
              <p:cNvPr id="54" name="Line 6"/>
              <p:cNvSpPr/>
              <p:nvPr/>
            </p:nvSpPr>
            <p:spPr>
              <a:xfrm>
                <a:off x="5291280" y="2014560"/>
                <a:ext cx="28548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7"/>
              <p:cNvSpPr/>
              <p:nvPr/>
            </p:nvSpPr>
            <p:spPr>
              <a:xfrm>
                <a:off x="5291280" y="2014560"/>
                <a:ext cx="1080" cy="21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" name="Group 8"/>
            <p:cNvGrpSpPr/>
            <p:nvPr/>
          </p:nvGrpSpPr>
          <p:grpSpPr>
            <a:xfrm>
              <a:off x="6154560" y="2014560"/>
              <a:ext cx="285840" cy="212760"/>
              <a:chOff x="6154560" y="2014560"/>
              <a:chExt cx="285840" cy="212760"/>
            </a:xfrm>
          </p:grpSpPr>
          <p:sp>
            <p:nvSpPr>
              <p:cNvPr id="57" name="Line 9"/>
              <p:cNvSpPr/>
              <p:nvPr/>
            </p:nvSpPr>
            <p:spPr>
              <a:xfrm>
                <a:off x="6154560" y="2014560"/>
                <a:ext cx="2858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10"/>
              <p:cNvSpPr/>
              <p:nvPr/>
            </p:nvSpPr>
            <p:spPr>
              <a:xfrm>
                <a:off x="6154560" y="2014560"/>
                <a:ext cx="1440" cy="21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Line 11"/>
            <p:cNvSpPr/>
            <p:nvPr/>
          </p:nvSpPr>
          <p:spPr>
            <a:xfrm>
              <a:off x="7020000" y="2086200"/>
              <a:ext cx="144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2"/>
            <p:cNvSpPr/>
            <p:nvPr/>
          </p:nvSpPr>
          <p:spPr>
            <a:xfrm>
              <a:off x="6883560" y="1870200"/>
              <a:ext cx="49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T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13"/>
            <p:cNvSpPr/>
            <p:nvPr/>
          </p:nvSpPr>
          <p:spPr>
            <a:xfrm>
              <a:off x="6732720" y="2157480"/>
              <a:ext cx="142920" cy="7308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4"/>
            <p:cNvSpPr/>
            <p:nvPr/>
          </p:nvSpPr>
          <p:spPr>
            <a:xfrm>
              <a:off x="6600960" y="2217960"/>
              <a:ext cx="43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15"/>
            <p:cNvSpPr/>
            <p:nvPr/>
          </p:nvSpPr>
          <p:spPr>
            <a:xfrm>
              <a:off x="6013440" y="1725840"/>
              <a:ext cx="36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16"/>
            <p:cNvSpPr/>
            <p:nvPr/>
          </p:nvSpPr>
          <p:spPr>
            <a:xfrm>
              <a:off x="5149800" y="1725840"/>
              <a:ext cx="36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17"/>
            <p:cNvSpPr/>
            <p:nvPr/>
          </p:nvSpPr>
          <p:spPr>
            <a:xfrm>
              <a:off x="3851280" y="1725840"/>
              <a:ext cx="36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18"/>
            <p:cNvSpPr/>
            <p:nvPr/>
          </p:nvSpPr>
          <p:spPr>
            <a:xfrm>
              <a:off x="2340000" y="3888000"/>
              <a:ext cx="53276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19"/>
            <p:cNvSpPr/>
            <p:nvPr/>
          </p:nvSpPr>
          <p:spPr>
            <a:xfrm>
              <a:off x="1236960" y="2111400"/>
              <a:ext cx="1029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CTC102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0"/>
            <p:cNvSpPr/>
            <p:nvPr/>
          </p:nvSpPr>
          <p:spPr>
            <a:xfrm>
              <a:off x="1258920" y="3757680"/>
              <a:ext cx="520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B-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9" name="Group 21"/>
            <p:cNvGrpSpPr/>
            <p:nvPr/>
          </p:nvGrpSpPr>
          <p:grpSpPr>
            <a:xfrm>
              <a:off x="5291280" y="3673440"/>
              <a:ext cx="285480" cy="212760"/>
              <a:chOff x="5291280" y="3673440"/>
              <a:chExt cx="285480" cy="212760"/>
            </a:xfrm>
          </p:grpSpPr>
          <p:sp>
            <p:nvSpPr>
              <p:cNvPr id="70" name="Line 22"/>
              <p:cNvSpPr/>
              <p:nvPr/>
            </p:nvSpPr>
            <p:spPr>
              <a:xfrm>
                <a:off x="5291280" y="3673440"/>
                <a:ext cx="28548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23"/>
              <p:cNvSpPr/>
              <p:nvPr/>
            </p:nvSpPr>
            <p:spPr>
              <a:xfrm>
                <a:off x="5291280" y="3673440"/>
                <a:ext cx="1080" cy="21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" name="Line 24"/>
            <p:cNvSpPr/>
            <p:nvPr/>
          </p:nvSpPr>
          <p:spPr>
            <a:xfrm>
              <a:off x="7020000" y="3745080"/>
              <a:ext cx="1440" cy="144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25"/>
            <p:cNvSpPr/>
            <p:nvPr/>
          </p:nvSpPr>
          <p:spPr>
            <a:xfrm>
              <a:off x="6883560" y="3529080"/>
              <a:ext cx="49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T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26"/>
            <p:cNvSpPr/>
            <p:nvPr/>
          </p:nvSpPr>
          <p:spPr>
            <a:xfrm>
              <a:off x="6732720" y="3816360"/>
              <a:ext cx="142920" cy="7308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pPr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27"/>
            <p:cNvSpPr/>
            <p:nvPr/>
          </p:nvSpPr>
          <p:spPr>
            <a:xfrm>
              <a:off x="6600960" y="3876840"/>
              <a:ext cx="431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28"/>
            <p:cNvSpPr/>
            <p:nvPr/>
          </p:nvSpPr>
          <p:spPr>
            <a:xfrm>
              <a:off x="5149800" y="3409920"/>
              <a:ext cx="36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30"/>
            <p:cNvSpPr/>
            <p:nvPr/>
          </p:nvSpPr>
          <p:spPr>
            <a:xfrm>
              <a:off x="5940000" y="1343160"/>
              <a:ext cx="1678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C  (16bp)  CAAANNNAA (SigK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31"/>
            <p:cNvSpPr/>
            <p:nvPr/>
          </p:nvSpPr>
          <p:spPr>
            <a:xfrm>
              <a:off x="4495680" y="2494080"/>
              <a:ext cx="187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ATTTTA  (14bp)  AATACTTT (SigE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32"/>
            <p:cNvSpPr/>
            <p:nvPr/>
          </p:nvSpPr>
          <p:spPr>
            <a:xfrm>
              <a:off x="3127680" y="1341360"/>
              <a:ext cx="1902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AATTCT  (14bp)  CATAAAAT (SigE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33"/>
            <p:cNvSpPr/>
            <p:nvPr/>
          </p:nvSpPr>
          <p:spPr>
            <a:xfrm>
              <a:off x="4567680" y="4079880"/>
              <a:ext cx="1896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TATTATA  (14bp)  AACACTTT (SigE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34"/>
            <p:cNvSpPr/>
            <p:nvPr/>
          </p:nvSpPr>
          <p:spPr>
            <a:xfrm>
              <a:off x="5940000" y="3146400"/>
              <a:ext cx="1678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C  (16bp)  CAAANNNAA (SigK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2" name="Group 35"/>
            <p:cNvGrpSpPr/>
            <p:nvPr/>
          </p:nvGrpSpPr>
          <p:grpSpPr>
            <a:xfrm>
              <a:off x="6156360" y="3668760"/>
              <a:ext cx="285840" cy="212760"/>
              <a:chOff x="6156360" y="3668760"/>
              <a:chExt cx="285840" cy="212760"/>
            </a:xfrm>
          </p:grpSpPr>
          <p:sp>
            <p:nvSpPr>
              <p:cNvPr id="83" name="Line 36"/>
              <p:cNvSpPr/>
              <p:nvPr/>
            </p:nvSpPr>
            <p:spPr>
              <a:xfrm>
                <a:off x="6156360" y="3668760"/>
                <a:ext cx="2858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37"/>
              <p:cNvSpPr/>
              <p:nvPr/>
            </p:nvSpPr>
            <p:spPr>
              <a:xfrm>
                <a:off x="6156360" y="3668760"/>
                <a:ext cx="1080" cy="212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5" name="Text Box 38"/>
            <p:cNvSpPr/>
            <p:nvPr/>
          </p:nvSpPr>
          <p:spPr>
            <a:xfrm>
              <a:off x="6014880" y="3379680"/>
              <a:ext cx="368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47840"/>
                  <a:tab algn="l" pos="896760"/>
                  <a:tab algn="l" pos="1346040"/>
                  <a:tab algn="l" pos="1795320"/>
                  <a:tab algn="l" pos="2244600"/>
                  <a:tab algn="l" pos="2693880"/>
                  <a:tab algn="l" pos="3143160"/>
                  <a:tab algn="l" pos="3592440"/>
                  <a:tab algn="l" pos="4041720"/>
                  <a:tab algn="l" pos="4491000"/>
                  <a:tab algn="l" pos="4940280"/>
                  <a:tab algn="l" pos="5389560"/>
                  <a:tab algn="l" pos="5838840"/>
                  <a:tab algn="l" pos="6288120"/>
                  <a:tab algn="l" pos="6737400"/>
                  <a:tab algn="l" pos="7186680"/>
                  <a:tab algn="l" pos="7635960"/>
                  <a:tab algn="l" pos="8085240"/>
                  <a:tab algn="l" pos="8534520"/>
                  <a:tab algn="l" pos="8983800"/>
                  <a:tab algn="l" pos="8985240"/>
                  <a:tab algn="l" pos="9434520"/>
                  <a:tab algn="l" pos="9883800"/>
                  <a:tab algn="l" pos="10333080"/>
                  <a:tab algn="l" pos="1078236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Text Box 1"/>
          <p:cNvSpPr/>
          <p:nvPr/>
        </p:nvSpPr>
        <p:spPr>
          <a:xfrm>
            <a:off x="431640" y="4941720"/>
            <a:ext cx="8280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Figure S6. Schematic presentation showing putative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promoter sequences in the chromosomal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strain NCTC10240 versus those in the PB-1 strain carrying the plasmid borne variant </a:t>
            </a:r>
            <a:r>
              <a:rPr b="1" i="1" lang="ja-JP" sz="1400" spc="-1" strike="noStrike">
                <a:solidFill>
                  <a:srgbClr val="000000"/>
                </a:solidFill>
                <a:latin typeface="Arial"/>
              </a:rPr>
              <a:t>cpe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 gene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4T00:01:52Z</dcterms:created>
  <dc:creator>MIYAMOTO</dc:creator>
  <dc:description/>
  <dc:language>en-US</dc:language>
  <cp:lastModifiedBy>MIYAMOTO</cp:lastModifiedBy>
  <dcterms:modified xsi:type="dcterms:W3CDTF">2011-05-04T00:04:49Z</dcterms:modified>
  <cp:revision>6</cp:revision>
  <dc:subject/>
  <dc:title>スライド 1</dc:title>
</cp:coreProperties>
</file>